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1" r:id="rId4"/>
    <p:sldId id="258" r:id="rId5"/>
    <p:sldId id="259" r:id="rId6"/>
    <p:sldId id="260" r:id="rId7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3018" y="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8656F-2113-4411-BC4B-10CB3AA6E6F3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81795-C148-4CDC-B110-8A2BC89427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03871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8656F-2113-4411-BC4B-10CB3AA6E6F3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81795-C148-4CDC-B110-8A2BC89427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40657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8656F-2113-4411-BC4B-10CB3AA6E6F3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81795-C148-4CDC-B110-8A2BC89427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21866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8656F-2113-4411-BC4B-10CB3AA6E6F3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81795-C148-4CDC-B110-8A2BC89427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33518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8656F-2113-4411-BC4B-10CB3AA6E6F3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81795-C148-4CDC-B110-8A2BC89427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34076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8656F-2113-4411-BC4B-10CB3AA6E6F3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81795-C148-4CDC-B110-8A2BC89427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743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8656F-2113-4411-BC4B-10CB3AA6E6F3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81795-C148-4CDC-B110-8A2BC89427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04579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8656F-2113-4411-BC4B-10CB3AA6E6F3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81795-C148-4CDC-B110-8A2BC89427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10611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8656F-2113-4411-BC4B-10CB3AA6E6F3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81795-C148-4CDC-B110-8A2BC89427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5706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8656F-2113-4411-BC4B-10CB3AA6E6F3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81795-C148-4CDC-B110-8A2BC89427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92940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8656F-2113-4411-BC4B-10CB3AA6E6F3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81795-C148-4CDC-B110-8A2BC89427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06491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68656F-2113-4411-BC4B-10CB3AA6E6F3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181795-C148-4CDC-B110-8A2BC89427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7537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tiff"/><Relationship Id="rId4" Type="http://schemas.openxmlformats.org/officeDocument/2006/relationships/image" Target="../media/image10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22273" y="692454"/>
            <a:ext cx="325762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S4 Fig Funnel plots – Maternal glycaemic control</a:t>
            </a:r>
          </a:p>
          <a:p>
            <a:endParaRPr lang="en-GB" sz="1200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1200" i="1" dirty="0" smtClean="0">
                <a:latin typeface="Times New Roman" pitchFamily="18" charset="0"/>
                <a:cs typeface="Times New Roman" pitchFamily="18" charset="0"/>
              </a:rPr>
              <a:t>Glyburide vs. insulin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86141" y="1480562"/>
            <a:ext cx="6575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A) FBS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521" y="1715667"/>
            <a:ext cx="3272641" cy="24833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3706737" y="1467218"/>
            <a:ext cx="6671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B) RBS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06525" y="1860099"/>
            <a:ext cx="3114753" cy="23118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330505" y="4106394"/>
            <a:ext cx="15247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i="1" dirty="0" smtClean="0">
                <a:latin typeface="Times New Roman" pitchFamily="18" charset="0"/>
                <a:cs typeface="Times New Roman" pitchFamily="18" charset="0"/>
              </a:rPr>
              <a:t>Metformin vs. insulin</a:t>
            </a:r>
            <a:endParaRPr lang="en-GB" sz="12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21035" y="4467750"/>
            <a:ext cx="6495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) FBS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2273" y="4744749"/>
            <a:ext cx="2759733" cy="19874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3651101" y="4456340"/>
            <a:ext cx="6751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D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) RBS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8531" y="7005027"/>
            <a:ext cx="3140521" cy="21389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569244" y="6898590"/>
            <a:ext cx="8130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E) HbA1c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32162" y="4839776"/>
            <a:ext cx="2985490" cy="20075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835164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8640" y="611560"/>
            <a:ext cx="28239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Funnel Plots - Maternal glycaemic control</a:t>
            </a:r>
          </a:p>
          <a:p>
            <a:endParaRPr lang="en-GB" sz="1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1200" i="1" dirty="0" smtClean="0">
                <a:latin typeface="Times New Roman" pitchFamily="18" charset="0"/>
                <a:cs typeface="Times New Roman" pitchFamily="18" charset="0"/>
              </a:rPr>
              <a:t>Glyburide vs. metformin</a:t>
            </a:r>
            <a:endParaRPr lang="en-GB" sz="12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81683" y="1403646"/>
            <a:ext cx="6575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A) FBS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717032" y="1412266"/>
            <a:ext cx="6671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B) RBS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" name="Picture 8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2364" y="1830574"/>
            <a:ext cx="3063782" cy="216542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73016" y="1934766"/>
            <a:ext cx="2991588" cy="20111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330167" y="4365684"/>
            <a:ext cx="8210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C) HbA1c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0167" y="4788024"/>
            <a:ext cx="3117009" cy="20780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52016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32656" y="755576"/>
            <a:ext cx="28625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Funnel plots – Total pregnancy weight gain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32656" y="1440088"/>
            <a:ext cx="14734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i="1" dirty="0" smtClean="0">
                <a:latin typeface="Times New Roman" pitchFamily="18" charset="0"/>
                <a:cs typeface="Times New Roman" pitchFamily="18" charset="0"/>
              </a:rPr>
              <a:t>Glyburide vs. insulin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809603" y="1436316"/>
            <a:ext cx="1499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i="1" dirty="0" smtClean="0">
                <a:latin typeface="Times New Roman" pitchFamily="18" charset="0"/>
                <a:cs typeface="Times New Roman" pitchFamily="18" charset="0"/>
              </a:rPr>
              <a:t>Metformin vs. insulin</a:t>
            </a: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8790" y="1945467"/>
            <a:ext cx="2978562" cy="21602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671" y="1960095"/>
            <a:ext cx="2808313" cy="21309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354410" y="4211960"/>
            <a:ext cx="16866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i="1" dirty="0" smtClean="0">
                <a:latin typeface="Times New Roman" pitchFamily="18" charset="0"/>
                <a:cs typeface="Times New Roman" pitchFamily="18" charset="0"/>
              </a:rPr>
              <a:t>Glyburide vs. metformin</a:t>
            </a:r>
          </a:p>
        </p:txBody>
      </p:sp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410" y="4572000"/>
            <a:ext cx="2956073" cy="24683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3507403" y="4211961"/>
            <a:ext cx="3350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i="1" dirty="0" smtClean="0">
                <a:latin typeface="Times New Roman" pitchFamily="18" charset="0"/>
                <a:cs typeface="Times New Roman" pitchFamily="18" charset="0"/>
              </a:rPr>
              <a:t>Metformin vs. insulin: Late gestational weight gain</a:t>
            </a:r>
          </a:p>
        </p:txBody>
      </p:sp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8790" y="4580359"/>
            <a:ext cx="3151543" cy="23914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762054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8238" y="778480"/>
            <a:ext cx="322556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Funnel plots – Birth weight, macrosomia &amp; LGA</a:t>
            </a:r>
          </a:p>
          <a:p>
            <a:endParaRPr lang="en-GB" sz="1200" i="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1200" i="1" dirty="0" smtClean="0">
                <a:latin typeface="Times New Roman" pitchFamily="18" charset="0"/>
                <a:cs typeface="Times New Roman" pitchFamily="18" charset="0"/>
              </a:rPr>
              <a:t>Glyburide vs. insulin</a:t>
            </a:r>
            <a:endParaRPr lang="en-GB" sz="12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04664" y="1481172"/>
            <a:ext cx="11608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A) Birth weight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635163" y="1481171"/>
            <a:ext cx="11480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B) Macrosomia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9434" y="1757054"/>
            <a:ext cx="3314410" cy="25150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9000" y="1758171"/>
            <a:ext cx="3177143" cy="24610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376578" y="4241145"/>
            <a:ext cx="6928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C) LGA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4868" y="4494133"/>
            <a:ext cx="2983542" cy="23111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4556593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5195" y="625928"/>
            <a:ext cx="322556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Funnel plots – Birth weight, macrosomia &amp; LGA</a:t>
            </a:r>
          </a:p>
          <a:p>
            <a:endParaRPr lang="en-GB" sz="1200" i="1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1200" i="1" dirty="0" smtClean="0">
                <a:latin typeface="Times New Roman" pitchFamily="18" charset="0"/>
                <a:cs typeface="Times New Roman" pitchFamily="18" charset="0"/>
              </a:rPr>
              <a:t>Metformin vs. insulin</a:t>
            </a:r>
            <a:endParaRPr lang="en-GB" sz="12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05195" y="1259633"/>
            <a:ext cx="10374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Birth weight 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709947" y="1259633"/>
            <a:ext cx="955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Macrosomia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2656" y="1746933"/>
            <a:ext cx="3076904" cy="205127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89384" y="1785045"/>
            <a:ext cx="3019737" cy="2013158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04664" y="4073460"/>
            <a:ext cx="6751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F) LGA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6431" y="4457196"/>
            <a:ext cx="3033129" cy="18678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30062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32656" y="611560"/>
            <a:ext cx="322556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Funnel plots – Birth weight, macrosomia &amp; LGA</a:t>
            </a:r>
          </a:p>
          <a:p>
            <a:endParaRPr lang="en-GB" sz="1200" i="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GB" sz="1200" i="1" dirty="0" smtClean="0">
                <a:latin typeface="Times New Roman" pitchFamily="18" charset="0"/>
                <a:cs typeface="Times New Roman" pitchFamily="18" charset="0"/>
              </a:rPr>
              <a:t>Glyburide </a:t>
            </a:r>
            <a:r>
              <a:rPr lang="en-GB" sz="1200" i="1" dirty="0" err="1" smtClean="0">
                <a:latin typeface="Times New Roman" pitchFamily="18" charset="0"/>
                <a:cs typeface="Times New Roman" pitchFamily="18" charset="0"/>
              </a:rPr>
              <a:t>vs</a:t>
            </a:r>
            <a:r>
              <a:rPr lang="en-GB" sz="1200" i="1" dirty="0" smtClean="0">
                <a:latin typeface="Times New Roman" pitchFamily="18" charset="0"/>
                <a:cs typeface="Times New Roman" pitchFamily="18" charset="0"/>
              </a:rPr>
              <a:t> metformin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58602" y="1491119"/>
            <a:ext cx="9989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Birth weight 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629397" y="1454116"/>
            <a:ext cx="9628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Macrosomia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3588" y="1942441"/>
            <a:ext cx="2667871" cy="1778580"/>
          </a:xfrm>
          <a:prstGeom prst="rect">
            <a:avLst/>
          </a:prstGeom>
        </p:spPr>
      </p:pic>
      <p:pic>
        <p:nvPicPr>
          <p:cNvPr id="6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89039" y="1884995"/>
            <a:ext cx="2793515" cy="18623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380009" y="4155579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LGA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8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0009" y="4572000"/>
            <a:ext cx="3016943" cy="19858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7111120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9</TotalTime>
  <Words>137</Words>
  <Application>Microsoft Office PowerPoint</Application>
  <PresentationFormat>On-screen Show (4:3)</PresentationFormat>
  <Paragraphs>38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Jane Adkins</cp:lastModifiedBy>
  <cp:revision>14</cp:revision>
  <cp:lastPrinted>2019-07-30T07:46:27Z</cp:lastPrinted>
  <dcterms:created xsi:type="dcterms:W3CDTF">2019-07-24T17:52:37Z</dcterms:created>
  <dcterms:modified xsi:type="dcterms:W3CDTF">2020-02-21T06:30:56Z</dcterms:modified>
</cp:coreProperties>
</file>